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5" d="100"/>
          <a:sy n="125" d="100"/>
        </p:scale>
        <p:origin x="1157" y="-30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0224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3968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1322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6317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7652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9749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7662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8755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77961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05529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17506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CA8973-58E3-4205-8F01-C4748FBB0F29}" type="datetimeFigureOut">
              <a:rPr lang="zh-CN" altLang="en-US" smtClean="0"/>
              <a:t>2022/8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2C4CA-BC8D-44E7-AD53-546B1B8C7F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1797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>
            <a:extLst>
              <a:ext uri="{FF2B5EF4-FFF2-40B4-BE49-F238E27FC236}">
                <a16:creationId xmlns:a16="http://schemas.microsoft.com/office/drawing/2014/main" id="{83B81038-559D-47CC-BEE1-ED10AE28B8FD}"/>
              </a:ext>
            </a:extLst>
          </p:cNvPr>
          <p:cNvGrpSpPr/>
          <p:nvPr/>
        </p:nvGrpSpPr>
        <p:grpSpPr>
          <a:xfrm>
            <a:off x="309703" y="170180"/>
            <a:ext cx="3026498" cy="2910700"/>
            <a:chOff x="309703" y="170180"/>
            <a:chExt cx="3026498" cy="2910700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AF80077A-429F-4EC3-923E-BDB2BE87C2A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25501" y="170180"/>
              <a:ext cx="2910700" cy="2910700"/>
            </a:xfrm>
            <a:prstGeom prst="rect">
              <a:avLst/>
            </a:prstGeom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59BBFD77-81A3-4E37-84AE-0406C645BF50}"/>
                </a:ext>
              </a:extLst>
            </p:cNvPr>
            <p:cNvSpPr txBox="1"/>
            <p:nvPr/>
          </p:nvSpPr>
          <p:spPr>
            <a:xfrm>
              <a:off x="309703" y="170180"/>
              <a:ext cx="231597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24E01453-318C-495A-9BC8-C4061E0E0ACB}"/>
              </a:ext>
            </a:extLst>
          </p:cNvPr>
          <p:cNvGrpSpPr/>
          <p:nvPr/>
        </p:nvGrpSpPr>
        <p:grpSpPr>
          <a:xfrm>
            <a:off x="3336201" y="170180"/>
            <a:ext cx="3094939" cy="2979420"/>
            <a:chOff x="3336201" y="170180"/>
            <a:chExt cx="3094939" cy="2979420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DA5B651A-A53E-4822-BD92-674966C0669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520440" y="238900"/>
              <a:ext cx="2910700" cy="2910700"/>
            </a:xfrm>
            <a:prstGeom prst="rect">
              <a:avLst/>
            </a:prstGeom>
          </p:spPr>
        </p:pic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A306C6B5-3AB6-43B1-B3A2-E7AD973DB25E}"/>
                </a:ext>
              </a:extLst>
            </p:cNvPr>
            <p:cNvSpPr txBox="1"/>
            <p:nvPr/>
          </p:nvSpPr>
          <p:spPr>
            <a:xfrm>
              <a:off x="3336201" y="170180"/>
              <a:ext cx="231597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D33FF1C3-65C1-4205-80DC-E6FA40D5D7FD}"/>
              </a:ext>
            </a:extLst>
          </p:cNvPr>
          <p:cNvGrpSpPr/>
          <p:nvPr/>
        </p:nvGrpSpPr>
        <p:grpSpPr>
          <a:xfrm>
            <a:off x="316104" y="2896278"/>
            <a:ext cx="4933936" cy="3092366"/>
            <a:chOff x="316104" y="2896278"/>
            <a:chExt cx="4933936" cy="3092366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FE0E71C3-3241-40E2-AEFB-8B43012DA1B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18300" y="3149600"/>
              <a:ext cx="4731740" cy="2839044"/>
            </a:xfrm>
            <a:prstGeom prst="rect">
              <a:avLst/>
            </a:prstGeom>
          </p:spPr>
        </p:pic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D1988AE8-0626-42B3-A4E0-B0A33F6B1798}"/>
                </a:ext>
              </a:extLst>
            </p:cNvPr>
            <p:cNvSpPr txBox="1"/>
            <p:nvPr/>
          </p:nvSpPr>
          <p:spPr>
            <a:xfrm>
              <a:off x="316104" y="2896278"/>
              <a:ext cx="231597" cy="3692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6985EB6C-2873-48E0-8010-F1409A6C9769}"/>
              </a:ext>
            </a:extLst>
          </p:cNvPr>
          <p:cNvSpPr txBox="1"/>
          <p:nvPr/>
        </p:nvSpPr>
        <p:spPr>
          <a:xfrm>
            <a:off x="316104" y="6184900"/>
            <a:ext cx="6115036" cy="923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.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-C) The 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sults of univariate Cox analysis and lasso regression analysis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306196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1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思涵</dc:creator>
  <cp:lastModifiedBy>MDPI</cp:lastModifiedBy>
  <cp:revision>4</cp:revision>
  <dcterms:created xsi:type="dcterms:W3CDTF">2022-05-01T05:12:34Z</dcterms:created>
  <dcterms:modified xsi:type="dcterms:W3CDTF">2022-08-30T11:13:55Z</dcterms:modified>
</cp:coreProperties>
</file>